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57" r:id="rId5"/>
    <p:sldId id="258" r:id="rId6"/>
    <p:sldId id="259" r:id="rId7"/>
    <p:sldId id="260" r:id="rId8"/>
    <p:sldId id="261" r:id="rId9"/>
    <p:sldId id="262" r:id="rId10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7"/>
    <p:restoredTop sz="94665"/>
  </p:normalViewPr>
  <p:slideViewPr>
    <p:cSldViewPr snapToGrid="0" snapToObjects="1">
      <p:cViewPr varScale="1">
        <p:scale>
          <a:sx n="109" d="100"/>
          <a:sy n="109" d="100"/>
        </p:scale>
        <p:origin x="14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42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567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884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502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91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517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420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345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93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27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281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B7E683-377D-444D-BEFB-2A38324204D5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13339-4669-DA49-BCE5-5D286BC2A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581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C8FA12C-F76D-5C4D-A535-6AB852510E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475" y="765125"/>
            <a:ext cx="7380639" cy="527519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9A3E2C-7B3E-DA44-8B7C-7ADF76BFD6BE}"/>
              </a:ext>
            </a:extLst>
          </p:cNvPr>
          <p:cNvSpPr txBox="1"/>
          <p:nvPr/>
        </p:nvSpPr>
        <p:spPr>
          <a:xfrm>
            <a:off x="488475" y="6237087"/>
            <a:ext cx="760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ient list</a:t>
            </a:r>
          </a:p>
        </p:txBody>
      </p:sp>
    </p:spTree>
    <p:extLst>
      <p:ext uri="{BB962C8B-B14F-4D97-AF65-F5344CB8AC3E}">
        <p14:creationId xmlns:p14="http://schemas.microsoft.com/office/powerpoint/2010/main" val="35001786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47D8E7C-F613-B446-8984-7663293469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607" y="586924"/>
            <a:ext cx="7112978" cy="517203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E5D9F6B-8FE1-CC49-A081-45DF6156E3B2}"/>
              </a:ext>
            </a:extLst>
          </p:cNvPr>
          <p:cNvSpPr txBox="1"/>
          <p:nvPr/>
        </p:nvSpPr>
        <p:spPr>
          <a:xfrm>
            <a:off x="468607" y="5995317"/>
            <a:ext cx="1084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ient case file</a:t>
            </a:r>
          </a:p>
        </p:txBody>
      </p:sp>
    </p:spTree>
    <p:extLst>
      <p:ext uri="{BB962C8B-B14F-4D97-AF65-F5344CB8AC3E}">
        <p14:creationId xmlns:p14="http://schemas.microsoft.com/office/powerpoint/2010/main" val="16190792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B08B38F-EF99-D346-B430-61F21837B3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369472"/>
            <a:ext cx="5866478" cy="59700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8442234-37DB-A440-B3E1-EB29F2E1D923}"/>
              </a:ext>
            </a:extLst>
          </p:cNvPr>
          <p:cNvSpPr txBox="1"/>
          <p:nvPr/>
        </p:nvSpPr>
        <p:spPr>
          <a:xfrm>
            <a:off x="1764544" y="6487767"/>
            <a:ext cx="19027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outine outcome measur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82625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ED4A1F3-1426-A94A-ADA8-75A074953C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3883" y="234562"/>
            <a:ext cx="5594755" cy="609919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FDBA138-E773-B04E-9955-29A5A77DEF7C}"/>
              </a:ext>
            </a:extLst>
          </p:cNvPr>
          <p:cNvSpPr txBox="1"/>
          <p:nvPr/>
        </p:nvSpPr>
        <p:spPr>
          <a:xfrm>
            <a:off x="1843883" y="6397196"/>
            <a:ext cx="1073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ppointments</a:t>
            </a:r>
          </a:p>
        </p:txBody>
      </p:sp>
    </p:spTree>
    <p:extLst>
      <p:ext uri="{BB962C8B-B14F-4D97-AF65-F5344CB8AC3E}">
        <p14:creationId xmlns:p14="http://schemas.microsoft.com/office/powerpoint/2010/main" val="20885484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BDB053B-3BD9-E742-ABE0-DBC43DC7CA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4838" y="254977"/>
            <a:ext cx="6023053" cy="615494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1DDA261-1AA2-744E-8D6F-70E2E59BE19E}"/>
              </a:ext>
            </a:extLst>
          </p:cNvPr>
          <p:cNvSpPr txBox="1"/>
          <p:nvPr/>
        </p:nvSpPr>
        <p:spPr>
          <a:xfrm>
            <a:off x="1704234" y="6477844"/>
            <a:ext cx="13057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ogress notes</a:t>
            </a:r>
          </a:p>
        </p:txBody>
      </p:sp>
    </p:spTree>
    <p:extLst>
      <p:ext uri="{BB962C8B-B14F-4D97-AF65-F5344CB8AC3E}">
        <p14:creationId xmlns:p14="http://schemas.microsoft.com/office/powerpoint/2010/main" val="14505395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1EB7433-C8FB-484B-881D-298D025DA1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6151" y="870437"/>
            <a:ext cx="7024255" cy="44577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57350DE-A47F-4148-8073-29BEB3DCF977}"/>
              </a:ext>
            </a:extLst>
          </p:cNvPr>
          <p:cNvSpPr txBox="1"/>
          <p:nvPr/>
        </p:nvSpPr>
        <p:spPr>
          <a:xfrm>
            <a:off x="756151" y="5899620"/>
            <a:ext cx="13298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omework review</a:t>
            </a:r>
          </a:p>
        </p:txBody>
      </p:sp>
    </p:spTree>
    <p:extLst>
      <p:ext uri="{BB962C8B-B14F-4D97-AF65-F5344CB8AC3E}">
        <p14:creationId xmlns:p14="http://schemas.microsoft.com/office/powerpoint/2010/main" val="2688912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79D796877130D4DB5E09A034F5071BD" ma:contentTypeVersion="13" ma:contentTypeDescription="Create a new document." ma:contentTypeScope="" ma:versionID="feee430570f47a2e9a757e335f650e52">
  <xsd:schema xmlns:xsd="http://www.w3.org/2001/XMLSchema" xmlns:xs="http://www.w3.org/2001/XMLSchema" xmlns:p="http://schemas.microsoft.com/office/2006/metadata/properties" xmlns:ns3="033e7d77-0493-452f-88e4-9522cce98248" xmlns:ns4="41d2de59-5231-46e2-a7a7-6b8cee87d748" targetNamespace="http://schemas.microsoft.com/office/2006/metadata/properties" ma:root="true" ma:fieldsID="bfae8a74e82c7d10d714259ff62f8560" ns3:_="" ns4:_="">
    <xsd:import namespace="033e7d77-0493-452f-88e4-9522cce98248"/>
    <xsd:import namespace="41d2de59-5231-46e2-a7a7-6b8cee87d74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3e7d77-0493-452f-88e4-9522cce9824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d2de59-5231-46e2-a7a7-6b8cee87d748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BC7EE4B-7CEC-42A5-A0B6-A9D49B4DC6E0}">
  <ds:schemaRefs>
    <ds:schemaRef ds:uri="http://purl.org/dc/elements/1.1/"/>
    <ds:schemaRef ds:uri="http://schemas.microsoft.com/office/2006/metadata/properties"/>
    <ds:schemaRef ds:uri="41d2de59-5231-46e2-a7a7-6b8cee87d748"/>
    <ds:schemaRef ds:uri="http://schemas.openxmlformats.org/package/2006/metadata/core-properties"/>
    <ds:schemaRef ds:uri="http://purl.org/dc/terms/"/>
    <ds:schemaRef ds:uri="http://schemas.microsoft.com/office/infopath/2007/PartnerControls"/>
    <ds:schemaRef ds:uri="http://schemas.microsoft.com/office/2006/documentManagement/types"/>
    <ds:schemaRef ds:uri="033e7d77-0493-452f-88e4-9522cce98248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41DCBDB9-25D6-4E04-94E3-07214B53277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C791F9D-9F2E-49C6-B601-13D4D76606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3e7d77-0493-452f-88e4-9522cce98248"/>
    <ds:schemaRef ds:uri="41d2de59-5231-46e2-a7a7-6b8cee87d74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13</Words>
  <Application>Microsoft Office PowerPoint</Application>
  <PresentationFormat>A4 Paper (210x297 mm)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Winchester</dc:creator>
  <cp:lastModifiedBy>Tessa Reardon</cp:lastModifiedBy>
  <cp:revision>6</cp:revision>
  <dcterms:created xsi:type="dcterms:W3CDTF">2021-01-12T16:59:42Z</dcterms:created>
  <dcterms:modified xsi:type="dcterms:W3CDTF">2022-04-07T05:44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79D796877130D4DB5E09A034F5071BD</vt:lpwstr>
  </property>
</Properties>
</file>